
<file path=[Content_Types].xml><?xml version="1.0" encoding="utf-8"?>
<Types xmlns="http://schemas.openxmlformats.org/package/2006/content-types">
  <Default Extension="jpeg" ContentType="image/jpeg"/>
  <Default Extension="JPG" ContentType="image/.jp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2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3.emf"/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6" name="图片 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51460" y="1976755"/>
            <a:ext cx="3155315" cy="155067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9175" y="521335"/>
            <a:ext cx="7920990" cy="22606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19170" y="3109595"/>
            <a:ext cx="8033385" cy="2276475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328295" y="186690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357245" y="45720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357245" y="278193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C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31140" y="5526405"/>
            <a:ext cx="11253470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Supplemental Figure 1. Aberrant splicing of the c.2376G&gt;A variant was detected in the paternal sample.(A) Agarose gel electrophoresis shows the products of RT-PCR with blood samples from the proband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’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s father (lanes 1 and 4), the proband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’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s mother (lanes 2 and 5) and unrelated healthy control (lanes 3 and 6). Lanes 1-3 stand for the amplicon targeting the EMC1 c.2376G&gt;A variation; and lanes 4-6 show the amplicon of an internal control. (B-C) The aberrant splicing in the paternal sample was confirmed by Sanger sequencing (B), which was absent in the maternal sample (C).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2442,&quot;width&quot;:4969}"/>
</p:tagLst>
</file>

<file path=ppt/tags/tag2.xml><?xml version="1.0" encoding="utf-8"?>
<p:tagLst xmlns:p="http://schemas.openxmlformats.org/presentationml/2006/main">
  <p:tag name="COMMONDATA" val="eyJoZGlkIjoiZGU3MWJjZjU0ODFlODBlZTBjODg0YTcwNGI4NzJkMzc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6</Words>
  <Application>WPS 演示</Application>
  <PresentationFormat>宽屏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Calibri</vt:lpstr>
      <vt:lpstr>微软雅黑</vt:lpstr>
      <vt:lpstr>Arial Unicode MS</vt:lpstr>
      <vt:lpstr>Times New Roman</vt:lpstr>
      <vt:lpstr>Tempus Sans ITC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Administrator</cp:lastModifiedBy>
  <cp:revision>2</cp:revision>
  <dcterms:created xsi:type="dcterms:W3CDTF">2023-03-27T05:19:00Z</dcterms:created>
  <dcterms:modified xsi:type="dcterms:W3CDTF">2023-03-27T05:21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3201A59CEE040FE8B955A0F5C7ED44B</vt:lpwstr>
  </property>
  <property fmtid="{D5CDD505-2E9C-101B-9397-08002B2CF9AE}" pid="3" name="KSOProductBuildVer">
    <vt:lpwstr>2052-11.1.0.12980</vt:lpwstr>
  </property>
</Properties>
</file>